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  <p:sldId id="261" r:id="rId5"/>
    <p:sldId id="256" r:id="rId6"/>
    <p:sldId id="26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8E5ECB2-63AD-4C96-B683-90155CC8E582}" v="29" dt="2021-05-06T17:51:16.8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93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184" y="4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tine Vazquez" userId="baaf5e5e6abb5d23" providerId="LiveId" clId="{28E5ECB2-63AD-4C96-B683-90155CC8E582}"/>
    <pc:docChg chg="custSel addSld modSld sldOrd">
      <pc:chgData name="Christine Vazquez" userId="baaf5e5e6abb5d23" providerId="LiveId" clId="{28E5ECB2-63AD-4C96-B683-90155CC8E582}" dt="2021-05-06T17:52:17.940" v="849" actId="207"/>
      <pc:docMkLst>
        <pc:docMk/>
      </pc:docMkLst>
      <pc:sldChg chg="addSp modSp mod">
        <pc:chgData name="Christine Vazquez" userId="baaf5e5e6abb5d23" providerId="LiveId" clId="{28E5ECB2-63AD-4C96-B683-90155CC8E582}" dt="2021-05-06T17:52:17.940" v="849" actId="207"/>
        <pc:sldMkLst>
          <pc:docMk/>
          <pc:sldMk cId="8382691" sldId="256"/>
        </pc:sldMkLst>
        <pc:spChg chg="add mod">
          <ac:chgData name="Christine Vazquez" userId="baaf5e5e6abb5d23" providerId="LiveId" clId="{28E5ECB2-63AD-4C96-B683-90155CC8E582}" dt="2021-05-06T16:36:15.525" v="300" actId="1076"/>
          <ac:spMkLst>
            <pc:docMk/>
            <pc:sldMk cId="8382691" sldId="256"/>
            <ac:spMk id="2" creationId="{844A76DC-96DB-4930-BBED-602D62421115}"/>
          </ac:spMkLst>
        </pc:spChg>
        <pc:spChg chg="add mod">
          <ac:chgData name="Christine Vazquez" userId="baaf5e5e6abb5d23" providerId="LiveId" clId="{28E5ECB2-63AD-4C96-B683-90155CC8E582}" dt="2021-05-06T16:35:36.701" v="295" actId="1037"/>
          <ac:spMkLst>
            <pc:docMk/>
            <pc:sldMk cId="8382691" sldId="256"/>
            <ac:spMk id="3" creationId="{865513D6-19BC-472C-A44F-F68DD8C068F0}"/>
          </ac:spMkLst>
        </pc:spChg>
        <pc:spChg chg="mod">
          <ac:chgData name="Christine Vazquez" userId="baaf5e5e6abb5d23" providerId="LiveId" clId="{28E5ECB2-63AD-4C96-B683-90155CC8E582}" dt="2021-05-06T17:51:53.373" v="846" actId="20577"/>
          <ac:spMkLst>
            <pc:docMk/>
            <pc:sldMk cId="8382691" sldId="256"/>
            <ac:spMk id="4" creationId="{6CB29B30-4CA7-4C3C-88AA-84A00B145E56}"/>
          </ac:spMkLst>
        </pc:spChg>
        <pc:spChg chg="add mod">
          <ac:chgData name="Christine Vazquez" userId="baaf5e5e6abb5d23" providerId="LiveId" clId="{28E5ECB2-63AD-4C96-B683-90155CC8E582}" dt="2021-05-06T17:52:11.134" v="848" actId="207"/>
          <ac:spMkLst>
            <pc:docMk/>
            <pc:sldMk cId="8382691" sldId="256"/>
            <ac:spMk id="5" creationId="{1793F54B-EC1C-4517-9E90-90C0B3C1872B}"/>
          </ac:spMkLst>
        </pc:spChg>
        <pc:spChg chg="add mod">
          <ac:chgData name="Christine Vazquez" userId="baaf5e5e6abb5d23" providerId="LiveId" clId="{28E5ECB2-63AD-4C96-B683-90155CC8E582}" dt="2021-05-06T17:52:17.940" v="849" actId="207"/>
          <ac:spMkLst>
            <pc:docMk/>
            <pc:sldMk cId="8382691" sldId="256"/>
            <ac:spMk id="7" creationId="{77B9C6F3-41B1-458B-AEDC-C3C9DC4B5D57}"/>
          </ac:spMkLst>
        </pc:spChg>
        <pc:spChg chg="add mod">
          <ac:chgData name="Christine Vazquez" userId="baaf5e5e6abb5d23" providerId="LiveId" clId="{28E5ECB2-63AD-4C96-B683-90155CC8E582}" dt="2021-05-06T16:35:32.536" v="282" actId="1076"/>
          <ac:spMkLst>
            <pc:docMk/>
            <pc:sldMk cId="8382691" sldId="256"/>
            <ac:spMk id="9" creationId="{27AFA2F1-A658-475A-AE5A-8D2E63A12169}"/>
          </ac:spMkLst>
        </pc:spChg>
        <pc:spChg chg="add mod">
          <ac:chgData name="Christine Vazquez" userId="baaf5e5e6abb5d23" providerId="LiveId" clId="{28E5ECB2-63AD-4C96-B683-90155CC8E582}" dt="2021-05-06T16:33:10.431" v="37" actId="20577"/>
          <ac:spMkLst>
            <pc:docMk/>
            <pc:sldMk cId="8382691" sldId="256"/>
            <ac:spMk id="11" creationId="{D216DBDF-D934-4EA1-A0E8-47A8FA3B1C47}"/>
          </ac:spMkLst>
        </pc:spChg>
        <pc:spChg chg="add mod">
          <ac:chgData name="Christine Vazquez" userId="baaf5e5e6abb5d23" providerId="LiveId" clId="{28E5ECB2-63AD-4C96-B683-90155CC8E582}" dt="2021-05-06T16:33:15.506" v="38"/>
          <ac:spMkLst>
            <pc:docMk/>
            <pc:sldMk cId="8382691" sldId="256"/>
            <ac:spMk id="13" creationId="{2CCE87A1-D8AA-4791-A055-9EA73B1600FA}"/>
          </ac:spMkLst>
        </pc:spChg>
        <pc:spChg chg="add mod">
          <ac:chgData name="Christine Vazquez" userId="baaf5e5e6abb5d23" providerId="LiveId" clId="{28E5ECB2-63AD-4C96-B683-90155CC8E582}" dt="2021-05-06T16:33:27.415" v="41" actId="1076"/>
          <ac:spMkLst>
            <pc:docMk/>
            <pc:sldMk cId="8382691" sldId="256"/>
            <ac:spMk id="15" creationId="{B4A845CB-AC71-4D3E-A562-826E702F43D3}"/>
          </ac:spMkLst>
        </pc:spChg>
        <pc:spChg chg="add mod">
          <ac:chgData name="Christine Vazquez" userId="baaf5e5e6abb5d23" providerId="LiveId" clId="{28E5ECB2-63AD-4C96-B683-90155CC8E582}" dt="2021-05-06T16:33:42.807" v="54" actId="1076"/>
          <ac:spMkLst>
            <pc:docMk/>
            <pc:sldMk cId="8382691" sldId="256"/>
            <ac:spMk id="16" creationId="{F07BDC33-BB40-49EB-9E55-195D1E0463CE}"/>
          </ac:spMkLst>
        </pc:spChg>
        <pc:spChg chg="add mod">
          <ac:chgData name="Christine Vazquez" userId="baaf5e5e6abb5d23" providerId="LiveId" clId="{28E5ECB2-63AD-4C96-B683-90155CC8E582}" dt="2021-05-06T16:35:26.173" v="281" actId="1076"/>
          <ac:spMkLst>
            <pc:docMk/>
            <pc:sldMk cId="8382691" sldId="256"/>
            <ac:spMk id="17" creationId="{546AEA08-858D-4A84-A2D0-668DD55173EC}"/>
          </ac:spMkLst>
        </pc:spChg>
        <pc:picChg chg="mod">
          <ac:chgData name="Christine Vazquez" userId="baaf5e5e6abb5d23" providerId="LiveId" clId="{28E5ECB2-63AD-4C96-B683-90155CC8E582}" dt="2021-05-06T16:31:49.596" v="2" actId="1076"/>
          <ac:picMkLst>
            <pc:docMk/>
            <pc:sldMk cId="8382691" sldId="256"/>
            <ac:picMk id="6" creationId="{7198F30A-FB55-4ACF-B01F-C8BED3AB7C23}"/>
          </ac:picMkLst>
        </pc:picChg>
        <pc:picChg chg="mod">
          <ac:chgData name="Christine Vazquez" userId="baaf5e5e6abb5d23" providerId="LiveId" clId="{28E5ECB2-63AD-4C96-B683-90155CC8E582}" dt="2021-05-06T16:35:36.701" v="295" actId="1037"/>
          <ac:picMkLst>
            <pc:docMk/>
            <pc:sldMk cId="8382691" sldId="256"/>
            <ac:picMk id="8" creationId="{B3C2DF4D-C1A7-4D91-8BA1-19CDCB4AC85C}"/>
          </ac:picMkLst>
        </pc:picChg>
        <pc:picChg chg="mod">
          <ac:chgData name="Christine Vazquez" userId="baaf5e5e6abb5d23" providerId="LiveId" clId="{28E5ECB2-63AD-4C96-B683-90155CC8E582}" dt="2021-05-06T16:31:56.380" v="4" actId="14100"/>
          <ac:picMkLst>
            <pc:docMk/>
            <pc:sldMk cId="8382691" sldId="256"/>
            <ac:picMk id="10" creationId="{30026CCB-5548-4DD0-805E-8C6BC991D70A}"/>
          </ac:picMkLst>
        </pc:picChg>
        <pc:cxnChg chg="add mod">
          <ac:chgData name="Christine Vazquez" userId="baaf5e5e6abb5d23" providerId="LiveId" clId="{28E5ECB2-63AD-4C96-B683-90155CC8E582}" dt="2021-05-06T16:36:09.945" v="299" actId="1582"/>
          <ac:cxnSpMkLst>
            <pc:docMk/>
            <pc:sldMk cId="8382691" sldId="256"/>
            <ac:cxnSpMk id="19" creationId="{7AC220F2-9534-481F-AF81-F169121F44B0}"/>
          </ac:cxnSpMkLst>
        </pc:cxnChg>
      </pc:sldChg>
      <pc:sldChg chg="addSp delSp modSp add mod ord">
        <pc:chgData name="Christine Vazquez" userId="baaf5e5e6abb5d23" providerId="LiveId" clId="{28E5ECB2-63AD-4C96-B683-90155CC8E582}" dt="2021-05-06T17:51:34.816" v="778" actId="20577"/>
        <pc:sldMkLst>
          <pc:docMk/>
          <pc:sldMk cId="3975921945" sldId="257"/>
        </pc:sldMkLst>
        <pc:spChg chg="del">
          <ac:chgData name="Christine Vazquez" userId="baaf5e5e6abb5d23" providerId="LiveId" clId="{28E5ECB2-63AD-4C96-B683-90155CC8E582}" dt="2021-05-06T16:37:27.773" v="366" actId="478"/>
          <ac:spMkLst>
            <pc:docMk/>
            <pc:sldMk cId="3975921945" sldId="257"/>
            <ac:spMk id="2" creationId="{844A76DC-96DB-4930-BBED-602D62421115}"/>
          </ac:spMkLst>
        </pc:spChg>
        <pc:spChg chg="del">
          <ac:chgData name="Christine Vazquez" userId="baaf5e5e6abb5d23" providerId="LiveId" clId="{28E5ECB2-63AD-4C96-B683-90155CC8E582}" dt="2021-05-06T16:37:36.572" v="374" actId="478"/>
          <ac:spMkLst>
            <pc:docMk/>
            <pc:sldMk cId="3975921945" sldId="257"/>
            <ac:spMk id="3" creationId="{865513D6-19BC-472C-A44F-F68DD8C068F0}"/>
          </ac:spMkLst>
        </pc:spChg>
        <pc:spChg chg="mod">
          <ac:chgData name="Christine Vazquez" userId="baaf5e5e6abb5d23" providerId="LiveId" clId="{28E5ECB2-63AD-4C96-B683-90155CC8E582}" dt="2021-05-06T17:51:34.816" v="778" actId="20577"/>
          <ac:spMkLst>
            <pc:docMk/>
            <pc:sldMk cId="3975921945" sldId="257"/>
            <ac:spMk id="4" creationId="{6CB29B30-4CA7-4C3C-88AA-84A00B145E56}"/>
          </ac:spMkLst>
        </pc:spChg>
        <pc:spChg chg="del mod">
          <ac:chgData name="Christine Vazquez" userId="baaf5e5e6abb5d23" providerId="LiveId" clId="{28E5ECB2-63AD-4C96-B683-90155CC8E582}" dt="2021-05-06T16:37:30.339" v="368" actId="478"/>
          <ac:spMkLst>
            <pc:docMk/>
            <pc:sldMk cId="3975921945" sldId="257"/>
            <ac:spMk id="9" creationId="{27AFA2F1-A658-475A-AE5A-8D2E63A12169}"/>
          </ac:spMkLst>
        </pc:spChg>
        <pc:spChg chg="del">
          <ac:chgData name="Christine Vazquez" userId="baaf5e5e6abb5d23" providerId="LiveId" clId="{28E5ECB2-63AD-4C96-B683-90155CC8E582}" dt="2021-05-06T16:37:34.164" v="372" actId="478"/>
          <ac:spMkLst>
            <pc:docMk/>
            <pc:sldMk cId="3975921945" sldId="257"/>
            <ac:spMk id="11" creationId="{D216DBDF-D934-4EA1-A0E8-47A8FA3B1C47}"/>
          </ac:spMkLst>
        </pc:spChg>
        <pc:spChg chg="del">
          <ac:chgData name="Christine Vazquez" userId="baaf5e5e6abb5d23" providerId="LiveId" clId="{28E5ECB2-63AD-4C96-B683-90155CC8E582}" dt="2021-05-06T16:37:35.350" v="373" actId="478"/>
          <ac:spMkLst>
            <pc:docMk/>
            <pc:sldMk cId="3975921945" sldId="257"/>
            <ac:spMk id="13" creationId="{2CCE87A1-D8AA-4791-A055-9EA73B1600FA}"/>
          </ac:spMkLst>
        </pc:spChg>
        <pc:spChg chg="del">
          <ac:chgData name="Christine Vazquez" userId="baaf5e5e6abb5d23" providerId="LiveId" clId="{28E5ECB2-63AD-4C96-B683-90155CC8E582}" dt="2021-05-06T16:37:52.003" v="379" actId="478"/>
          <ac:spMkLst>
            <pc:docMk/>
            <pc:sldMk cId="3975921945" sldId="257"/>
            <ac:spMk id="15" creationId="{B4A845CB-AC71-4D3E-A562-826E702F43D3}"/>
          </ac:spMkLst>
        </pc:spChg>
        <pc:spChg chg="del">
          <ac:chgData name="Christine Vazquez" userId="baaf5e5e6abb5d23" providerId="LiveId" clId="{28E5ECB2-63AD-4C96-B683-90155CC8E582}" dt="2021-05-06T16:37:49.427" v="377" actId="478"/>
          <ac:spMkLst>
            <pc:docMk/>
            <pc:sldMk cId="3975921945" sldId="257"/>
            <ac:spMk id="16" creationId="{F07BDC33-BB40-49EB-9E55-195D1E0463CE}"/>
          </ac:spMkLst>
        </pc:spChg>
        <pc:spChg chg="mod">
          <ac:chgData name="Christine Vazquez" userId="baaf5e5e6abb5d23" providerId="LiveId" clId="{28E5ECB2-63AD-4C96-B683-90155CC8E582}" dt="2021-05-06T17:35:28.203" v="418" actId="1076"/>
          <ac:spMkLst>
            <pc:docMk/>
            <pc:sldMk cId="3975921945" sldId="257"/>
            <ac:spMk id="17" creationId="{546AEA08-858D-4A84-A2D0-668DD55173EC}"/>
          </ac:spMkLst>
        </pc:spChg>
        <pc:spChg chg="add mod">
          <ac:chgData name="Christine Vazquez" userId="baaf5e5e6abb5d23" providerId="LiveId" clId="{28E5ECB2-63AD-4C96-B683-90155CC8E582}" dt="2021-05-06T17:35:21.657" v="415" actId="1076"/>
          <ac:spMkLst>
            <pc:docMk/>
            <pc:sldMk cId="3975921945" sldId="257"/>
            <ac:spMk id="21" creationId="{5B2F8959-BE0B-4759-9FE7-E07A60CCA5F3}"/>
          </ac:spMkLst>
        </pc:spChg>
        <pc:spChg chg="add mod">
          <ac:chgData name="Christine Vazquez" userId="baaf5e5e6abb5d23" providerId="LiveId" clId="{28E5ECB2-63AD-4C96-B683-90155CC8E582}" dt="2021-05-06T17:36:41.043" v="465" actId="1076"/>
          <ac:spMkLst>
            <pc:docMk/>
            <pc:sldMk cId="3975921945" sldId="257"/>
            <ac:spMk id="24" creationId="{7C1BF507-4AF3-48D4-835B-BDBDF75E9FE2}"/>
          </ac:spMkLst>
        </pc:spChg>
        <pc:spChg chg="add mod">
          <ac:chgData name="Christine Vazquez" userId="baaf5e5e6abb5d23" providerId="LiveId" clId="{28E5ECB2-63AD-4C96-B683-90155CC8E582}" dt="2021-05-06T17:36:45.033" v="466" actId="1076"/>
          <ac:spMkLst>
            <pc:docMk/>
            <pc:sldMk cId="3975921945" sldId="257"/>
            <ac:spMk id="25" creationId="{5B2A5F7E-365A-484C-97C0-72D5259C6D92}"/>
          </ac:spMkLst>
        </pc:spChg>
        <pc:spChg chg="add mod">
          <ac:chgData name="Christine Vazquez" userId="baaf5e5e6abb5d23" providerId="LiveId" clId="{28E5ECB2-63AD-4C96-B683-90155CC8E582}" dt="2021-05-06T17:37:47.963" v="484" actId="1076"/>
          <ac:spMkLst>
            <pc:docMk/>
            <pc:sldMk cId="3975921945" sldId="257"/>
            <ac:spMk id="30" creationId="{9DD890E9-1997-4555-A981-91A760DA248C}"/>
          </ac:spMkLst>
        </pc:spChg>
        <pc:spChg chg="add mod">
          <ac:chgData name="Christine Vazquez" userId="baaf5e5e6abb5d23" providerId="LiveId" clId="{28E5ECB2-63AD-4C96-B683-90155CC8E582}" dt="2021-05-06T17:38:08.671" v="487" actId="207"/>
          <ac:spMkLst>
            <pc:docMk/>
            <pc:sldMk cId="3975921945" sldId="257"/>
            <ac:spMk id="31" creationId="{DB4FF0F2-4C02-4A25-98DD-4D79DEC760FA}"/>
          </ac:spMkLst>
        </pc:spChg>
        <pc:spChg chg="add mod">
          <ac:chgData name="Christine Vazquez" userId="baaf5e5e6abb5d23" providerId="LiveId" clId="{28E5ECB2-63AD-4C96-B683-90155CC8E582}" dt="2021-05-06T17:40:00.055" v="514" actId="14100"/>
          <ac:spMkLst>
            <pc:docMk/>
            <pc:sldMk cId="3975921945" sldId="257"/>
            <ac:spMk id="32" creationId="{85AFAD78-CA40-4DAF-B1C4-3991986C932C}"/>
          </ac:spMkLst>
        </pc:spChg>
        <pc:spChg chg="add mod">
          <ac:chgData name="Christine Vazquez" userId="baaf5e5e6abb5d23" providerId="LiveId" clId="{28E5ECB2-63AD-4C96-B683-90155CC8E582}" dt="2021-05-06T17:48:59.519" v="710" actId="1076"/>
          <ac:spMkLst>
            <pc:docMk/>
            <pc:sldMk cId="3975921945" sldId="257"/>
            <ac:spMk id="33" creationId="{C6E60C70-8A19-4E0D-AE32-814821C440C4}"/>
          </ac:spMkLst>
        </pc:spChg>
        <pc:picChg chg="del">
          <ac:chgData name="Christine Vazquez" userId="baaf5e5e6abb5d23" providerId="LiveId" clId="{28E5ECB2-63AD-4C96-B683-90155CC8E582}" dt="2021-05-06T16:37:32.168" v="370" actId="478"/>
          <ac:picMkLst>
            <pc:docMk/>
            <pc:sldMk cId="3975921945" sldId="257"/>
            <ac:picMk id="6" creationId="{7198F30A-FB55-4ACF-B01F-C8BED3AB7C23}"/>
          </ac:picMkLst>
        </pc:picChg>
        <pc:picChg chg="del">
          <ac:chgData name="Christine Vazquez" userId="baaf5e5e6abb5d23" providerId="LiveId" clId="{28E5ECB2-63AD-4C96-B683-90155CC8E582}" dt="2021-05-06T16:37:37.423" v="375" actId="478"/>
          <ac:picMkLst>
            <pc:docMk/>
            <pc:sldMk cId="3975921945" sldId="257"/>
            <ac:picMk id="8" creationId="{B3C2DF4D-C1A7-4D91-8BA1-19CDCB4AC85C}"/>
          </ac:picMkLst>
        </pc:picChg>
        <pc:picChg chg="del">
          <ac:chgData name="Christine Vazquez" userId="baaf5e5e6abb5d23" providerId="LiveId" clId="{28E5ECB2-63AD-4C96-B683-90155CC8E582}" dt="2021-05-06T16:37:33.007" v="371" actId="478"/>
          <ac:picMkLst>
            <pc:docMk/>
            <pc:sldMk cId="3975921945" sldId="257"/>
            <ac:picMk id="10" creationId="{30026CCB-5548-4DD0-805E-8C6BC991D70A}"/>
          </ac:picMkLst>
        </pc:picChg>
        <pc:picChg chg="del">
          <ac:chgData name="Christine Vazquez" userId="baaf5e5e6abb5d23" providerId="LiveId" clId="{28E5ECB2-63AD-4C96-B683-90155CC8E582}" dt="2021-05-06T16:37:48.323" v="376" actId="478"/>
          <ac:picMkLst>
            <pc:docMk/>
            <pc:sldMk cId="3975921945" sldId="257"/>
            <ac:picMk id="12" creationId="{2AC0EE73-081D-4C81-9DA2-7BDCC5FF91B5}"/>
          </ac:picMkLst>
        </pc:picChg>
        <pc:picChg chg="del">
          <ac:chgData name="Christine Vazquez" userId="baaf5e5e6abb5d23" providerId="LiveId" clId="{28E5ECB2-63AD-4C96-B683-90155CC8E582}" dt="2021-05-06T16:37:50.228" v="378" actId="478"/>
          <ac:picMkLst>
            <pc:docMk/>
            <pc:sldMk cId="3975921945" sldId="257"/>
            <ac:picMk id="14" creationId="{E0CF60F0-7846-4A48-AE5A-5C64D175CD0B}"/>
          </ac:picMkLst>
        </pc:picChg>
        <pc:picChg chg="add mod modCrop">
          <ac:chgData name="Christine Vazquez" userId="baaf5e5e6abb5d23" providerId="LiveId" clId="{28E5ECB2-63AD-4C96-B683-90155CC8E582}" dt="2021-05-06T17:35:02.185" v="389" actId="1076"/>
          <ac:picMkLst>
            <pc:docMk/>
            <pc:sldMk cId="3975921945" sldId="257"/>
            <ac:picMk id="20" creationId="{AC2F7273-2F7B-4C53-995A-F2F78424FADF}"/>
          </ac:picMkLst>
        </pc:picChg>
        <pc:picChg chg="add mod modCrop">
          <ac:chgData name="Christine Vazquez" userId="baaf5e5e6abb5d23" providerId="LiveId" clId="{28E5ECB2-63AD-4C96-B683-90155CC8E582}" dt="2021-05-06T17:36:37.637" v="464" actId="1076"/>
          <ac:picMkLst>
            <pc:docMk/>
            <pc:sldMk cId="3975921945" sldId="257"/>
            <ac:picMk id="23" creationId="{AE9DC049-2CA0-4E11-B6B4-14F139C188BC}"/>
          </ac:picMkLst>
        </pc:picChg>
        <pc:picChg chg="add mod modCrop">
          <ac:chgData name="Christine Vazquez" userId="baaf5e5e6abb5d23" providerId="LiveId" clId="{28E5ECB2-63AD-4C96-B683-90155CC8E582}" dt="2021-05-06T17:37:21.453" v="478" actId="1076"/>
          <ac:picMkLst>
            <pc:docMk/>
            <pc:sldMk cId="3975921945" sldId="257"/>
            <ac:picMk id="27" creationId="{41FA0C26-D485-4332-9B12-74F40094488E}"/>
          </ac:picMkLst>
        </pc:picChg>
        <pc:picChg chg="add del mod">
          <ac:chgData name="Christine Vazquez" userId="baaf5e5e6abb5d23" providerId="LiveId" clId="{28E5ECB2-63AD-4C96-B683-90155CC8E582}" dt="2021-05-06T17:37:32.412" v="482" actId="478"/>
          <ac:picMkLst>
            <pc:docMk/>
            <pc:sldMk cId="3975921945" sldId="257"/>
            <ac:picMk id="29" creationId="{4385D2DB-6F72-4314-A088-E949371767FB}"/>
          </ac:picMkLst>
        </pc:picChg>
        <pc:cxnChg chg="del">
          <ac:chgData name="Christine Vazquez" userId="baaf5e5e6abb5d23" providerId="LiveId" clId="{28E5ECB2-63AD-4C96-B683-90155CC8E582}" dt="2021-05-06T16:37:31.307" v="369" actId="478"/>
          <ac:cxnSpMkLst>
            <pc:docMk/>
            <pc:sldMk cId="3975921945" sldId="257"/>
            <ac:cxnSpMk id="19" creationId="{7AC220F2-9534-481F-AF81-F169121F44B0}"/>
          </ac:cxnSpMkLst>
        </pc:cxnChg>
      </pc:sldChg>
      <pc:sldChg chg="addSp delSp modSp add mod">
        <pc:chgData name="Christine Vazquez" userId="baaf5e5e6abb5d23" providerId="LiveId" clId="{28E5ECB2-63AD-4C96-B683-90155CC8E582}" dt="2021-05-06T17:51:44.254" v="817" actId="20577"/>
        <pc:sldMkLst>
          <pc:docMk/>
          <pc:sldMk cId="294924001" sldId="258"/>
        </pc:sldMkLst>
        <pc:spChg chg="mod">
          <ac:chgData name="Christine Vazquez" userId="baaf5e5e6abb5d23" providerId="LiveId" clId="{28E5ECB2-63AD-4C96-B683-90155CC8E582}" dt="2021-05-06T17:51:44.254" v="817" actId="20577"/>
          <ac:spMkLst>
            <pc:docMk/>
            <pc:sldMk cId="294924001" sldId="258"/>
            <ac:spMk id="4" creationId="{6CB29B30-4CA7-4C3C-88AA-84A00B145E56}"/>
          </ac:spMkLst>
        </pc:spChg>
        <pc:spChg chg="del">
          <ac:chgData name="Christine Vazquez" userId="baaf5e5e6abb5d23" providerId="LiveId" clId="{28E5ECB2-63AD-4C96-B683-90155CC8E582}" dt="2021-05-06T17:39:01.299" v="490" actId="478"/>
          <ac:spMkLst>
            <pc:docMk/>
            <pc:sldMk cId="294924001" sldId="258"/>
            <ac:spMk id="5" creationId="{1793F54B-EC1C-4517-9E90-90C0B3C1872B}"/>
          </ac:spMkLst>
        </pc:spChg>
        <pc:spChg chg="del">
          <ac:chgData name="Christine Vazquez" userId="baaf5e5e6abb5d23" providerId="LiveId" clId="{28E5ECB2-63AD-4C96-B683-90155CC8E582}" dt="2021-05-06T17:39:01.299" v="490" actId="478"/>
          <ac:spMkLst>
            <pc:docMk/>
            <pc:sldMk cId="294924001" sldId="258"/>
            <ac:spMk id="7" creationId="{77B9C6F3-41B1-458B-AEDC-C3C9DC4B5D57}"/>
          </ac:spMkLst>
        </pc:spChg>
        <pc:spChg chg="add mod">
          <ac:chgData name="Christine Vazquez" userId="baaf5e5e6abb5d23" providerId="LiveId" clId="{28E5ECB2-63AD-4C96-B683-90155CC8E582}" dt="2021-05-06T17:40:10.563" v="522" actId="1076"/>
          <ac:spMkLst>
            <pc:docMk/>
            <pc:sldMk cId="294924001" sldId="258"/>
            <ac:spMk id="18" creationId="{3BAF2E31-A226-4F22-9372-665337AE2514}"/>
          </ac:spMkLst>
        </pc:spChg>
        <pc:spChg chg="del">
          <ac:chgData name="Christine Vazquez" userId="baaf5e5e6abb5d23" providerId="LiveId" clId="{28E5ECB2-63AD-4C96-B683-90155CC8E582}" dt="2021-05-06T17:39:01.299" v="490" actId="478"/>
          <ac:spMkLst>
            <pc:docMk/>
            <pc:sldMk cId="294924001" sldId="258"/>
            <ac:spMk id="21" creationId="{5B2F8959-BE0B-4759-9FE7-E07A60CCA5F3}"/>
          </ac:spMkLst>
        </pc:spChg>
        <pc:spChg chg="del">
          <ac:chgData name="Christine Vazquez" userId="baaf5e5e6abb5d23" providerId="LiveId" clId="{28E5ECB2-63AD-4C96-B683-90155CC8E582}" dt="2021-05-06T17:39:01.299" v="490" actId="478"/>
          <ac:spMkLst>
            <pc:docMk/>
            <pc:sldMk cId="294924001" sldId="258"/>
            <ac:spMk id="24" creationId="{7C1BF507-4AF3-48D4-835B-BDBDF75E9FE2}"/>
          </ac:spMkLst>
        </pc:spChg>
        <pc:spChg chg="del mod">
          <ac:chgData name="Christine Vazquez" userId="baaf5e5e6abb5d23" providerId="LiveId" clId="{28E5ECB2-63AD-4C96-B683-90155CC8E582}" dt="2021-05-06T17:39:01.299" v="490" actId="478"/>
          <ac:spMkLst>
            <pc:docMk/>
            <pc:sldMk cId="294924001" sldId="258"/>
            <ac:spMk id="25" creationId="{5B2A5F7E-365A-484C-97C0-72D5259C6D92}"/>
          </ac:spMkLst>
        </pc:spChg>
        <pc:spChg chg="add mod">
          <ac:chgData name="Christine Vazquez" userId="baaf5e5e6abb5d23" providerId="LiveId" clId="{28E5ECB2-63AD-4C96-B683-90155CC8E582}" dt="2021-05-06T17:40:50.565" v="541" actId="20577"/>
          <ac:spMkLst>
            <pc:docMk/>
            <pc:sldMk cId="294924001" sldId="258"/>
            <ac:spMk id="26" creationId="{595DF994-1F5F-4755-BC56-E9B60D3D3A68}"/>
          </ac:spMkLst>
        </pc:spChg>
        <pc:spChg chg="add mod">
          <ac:chgData name="Christine Vazquez" userId="baaf5e5e6abb5d23" providerId="LiveId" clId="{28E5ECB2-63AD-4C96-B683-90155CC8E582}" dt="2021-05-06T17:41:01.206" v="543" actId="1076"/>
          <ac:spMkLst>
            <pc:docMk/>
            <pc:sldMk cId="294924001" sldId="258"/>
            <ac:spMk id="28" creationId="{91B962E1-2098-42A5-A712-F09DFAD2A9B5}"/>
          </ac:spMkLst>
        </pc:spChg>
        <pc:spChg chg="del">
          <ac:chgData name="Christine Vazquez" userId="baaf5e5e6abb5d23" providerId="LiveId" clId="{28E5ECB2-63AD-4C96-B683-90155CC8E582}" dt="2021-05-06T17:39:01.299" v="490" actId="478"/>
          <ac:spMkLst>
            <pc:docMk/>
            <pc:sldMk cId="294924001" sldId="258"/>
            <ac:spMk id="30" creationId="{9DD890E9-1997-4555-A981-91A760DA248C}"/>
          </ac:spMkLst>
        </pc:spChg>
        <pc:spChg chg="del">
          <ac:chgData name="Christine Vazquez" userId="baaf5e5e6abb5d23" providerId="LiveId" clId="{28E5ECB2-63AD-4C96-B683-90155CC8E582}" dt="2021-05-06T17:39:01.299" v="490" actId="478"/>
          <ac:spMkLst>
            <pc:docMk/>
            <pc:sldMk cId="294924001" sldId="258"/>
            <ac:spMk id="31" creationId="{DB4FF0F2-4C02-4A25-98DD-4D79DEC760FA}"/>
          </ac:spMkLst>
        </pc:spChg>
        <pc:picChg chg="add del mod">
          <ac:chgData name="Christine Vazquez" userId="baaf5e5e6abb5d23" providerId="LiveId" clId="{28E5ECB2-63AD-4C96-B683-90155CC8E582}" dt="2021-05-06T17:39:15.146" v="493" actId="478"/>
          <ac:picMkLst>
            <pc:docMk/>
            <pc:sldMk cId="294924001" sldId="258"/>
            <ac:picMk id="3" creationId="{BE9FC8CD-B1B9-4E6B-BFC3-4EBD2F6B1EC9}"/>
          </ac:picMkLst>
        </pc:picChg>
        <pc:picChg chg="add mod modCrop">
          <ac:chgData name="Christine Vazquez" userId="baaf5e5e6abb5d23" providerId="LiveId" clId="{28E5ECB2-63AD-4C96-B683-90155CC8E582}" dt="2021-05-06T17:39:47.516" v="502" actId="1076"/>
          <ac:picMkLst>
            <pc:docMk/>
            <pc:sldMk cId="294924001" sldId="258"/>
            <ac:picMk id="8" creationId="{A60DD0C6-6431-4A59-AF16-8350FED8335F}"/>
          </ac:picMkLst>
        </pc:picChg>
        <pc:picChg chg="add mod modCrop">
          <ac:chgData name="Christine Vazquez" userId="baaf5e5e6abb5d23" providerId="LiveId" clId="{28E5ECB2-63AD-4C96-B683-90155CC8E582}" dt="2021-05-06T17:40:38.526" v="531" actId="1076"/>
          <ac:picMkLst>
            <pc:docMk/>
            <pc:sldMk cId="294924001" sldId="258"/>
            <ac:picMk id="10" creationId="{E4712A84-9719-420E-A5BD-FC03ED9F14F2}"/>
          </ac:picMkLst>
        </pc:picChg>
        <pc:picChg chg="add del mod">
          <ac:chgData name="Christine Vazquez" userId="baaf5e5e6abb5d23" providerId="LiveId" clId="{28E5ECB2-63AD-4C96-B683-90155CC8E582}" dt="2021-05-06T17:40:41.676" v="535" actId="478"/>
          <ac:picMkLst>
            <pc:docMk/>
            <pc:sldMk cId="294924001" sldId="258"/>
            <ac:picMk id="12" creationId="{3292FFCA-DDC3-4C1F-9DBB-981F009D84E1}"/>
          </ac:picMkLst>
        </pc:picChg>
        <pc:picChg chg="del">
          <ac:chgData name="Christine Vazquez" userId="baaf5e5e6abb5d23" providerId="LiveId" clId="{28E5ECB2-63AD-4C96-B683-90155CC8E582}" dt="2021-05-06T17:39:01.299" v="490" actId="478"/>
          <ac:picMkLst>
            <pc:docMk/>
            <pc:sldMk cId="294924001" sldId="258"/>
            <ac:picMk id="20" creationId="{AC2F7273-2F7B-4C53-995A-F2F78424FADF}"/>
          </ac:picMkLst>
        </pc:picChg>
        <pc:picChg chg="del mod">
          <ac:chgData name="Christine Vazquez" userId="baaf5e5e6abb5d23" providerId="LiveId" clId="{28E5ECB2-63AD-4C96-B683-90155CC8E582}" dt="2021-05-06T17:39:01.299" v="490" actId="478"/>
          <ac:picMkLst>
            <pc:docMk/>
            <pc:sldMk cId="294924001" sldId="258"/>
            <ac:picMk id="23" creationId="{AE9DC049-2CA0-4E11-B6B4-14F139C188BC}"/>
          </ac:picMkLst>
        </pc:picChg>
        <pc:picChg chg="del mod">
          <ac:chgData name="Christine Vazquez" userId="baaf5e5e6abb5d23" providerId="LiveId" clId="{28E5ECB2-63AD-4C96-B683-90155CC8E582}" dt="2021-05-06T17:39:01.299" v="490" actId="478"/>
          <ac:picMkLst>
            <pc:docMk/>
            <pc:sldMk cId="294924001" sldId="258"/>
            <ac:picMk id="27" creationId="{41FA0C26-D485-4332-9B12-74F40094488E}"/>
          </ac:picMkLst>
        </pc:picChg>
      </pc:sldChg>
      <pc:sldChg chg="addSp delSp modSp add mod">
        <pc:chgData name="Christine Vazquez" userId="baaf5e5e6abb5d23" providerId="LiveId" clId="{28E5ECB2-63AD-4C96-B683-90155CC8E582}" dt="2021-05-06T17:51:27.350" v="749" actId="14100"/>
        <pc:sldMkLst>
          <pc:docMk/>
          <pc:sldMk cId="4048040299" sldId="259"/>
        </pc:sldMkLst>
        <pc:spChg chg="del">
          <ac:chgData name="Christine Vazquez" userId="baaf5e5e6abb5d23" providerId="LiveId" clId="{28E5ECB2-63AD-4C96-B683-90155CC8E582}" dt="2021-05-06T17:51:04.554" v="713" actId="478"/>
          <ac:spMkLst>
            <pc:docMk/>
            <pc:sldMk cId="4048040299" sldId="259"/>
            <ac:spMk id="2" creationId="{035CBD01-4665-42CB-AFDE-68C9CF32FD2C}"/>
          </ac:spMkLst>
        </pc:spChg>
        <pc:spChg chg="add mod">
          <ac:chgData name="Christine Vazquez" userId="baaf5e5e6abb5d23" providerId="LiveId" clId="{28E5ECB2-63AD-4C96-B683-90155CC8E582}" dt="2021-05-06T17:51:27.350" v="749" actId="14100"/>
          <ac:spMkLst>
            <pc:docMk/>
            <pc:sldMk cId="4048040299" sldId="259"/>
            <ac:spMk id="3" creationId="{5731BDFC-2A07-4152-908A-621A9BE799B1}"/>
          </ac:spMkLst>
        </pc:spChg>
        <pc:spChg chg="del">
          <ac:chgData name="Christine Vazquez" userId="baaf5e5e6abb5d23" providerId="LiveId" clId="{28E5ECB2-63AD-4C96-B683-90155CC8E582}" dt="2021-05-06T17:51:01.150" v="712" actId="478"/>
          <ac:spMkLst>
            <pc:docMk/>
            <pc:sldMk cId="4048040299" sldId="259"/>
            <ac:spMk id="6" creationId="{350A3D53-F1A1-4615-A4A6-845E6748DDE8}"/>
          </ac:spMkLst>
        </pc:spChg>
        <pc:spChg chg="mod">
          <ac:chgData name="Christine Vazquez" userId="baaf5e5e6abb5d23" providerId="LiveId" clId="{28E5ECB2-63AD-4C96-B683-90155CC8E582}" dt="2021-05-06T17:51:08.885" v="714" actId="1076"/>
          <ac:spMkLst>
            <pc:docMk/>
            <pc:sldMk cId="4048040299" sldId="259"/>
            <ac:spMk id="7" creationId="{2EAD9480-4627-4C94-A526-63A7DF9DF38C}"/>
          </ac:spMkLst>
        </pc:spChg>
        <pc:spChg chg="mod">
          <ac:chgData name="Christine Vazquez" userId="baaf5e5e6abb5d23" providerId="LiveId" clId="{28E5ECB2-63AD-4C96-B683-90155CC8E582}" dt="2021-05-06T17:51:08.885" v="714" actId="1076"/>
          <ac:spMkLst>
            <pc:docMk/>
            <pc:sldMk cId="4048040299" sldId="259"/>
            <ac:spMk id="11" creationId="{7A56D55C-766F-4326-A5B7-DB2956E4A9E4}"/>
          </ac:spMkLst>
        </pc:spChg>
        <pc:spChg chg="del">
          <ac:chgData name="Christine Vazquez" userId="baaf5e5e6abb5d23" providerId="LiveId" clId="{28E5ECB2-63AD-4C96-B683-90155CC8E582}" dt="2021-05-06T17:51:01.150" v="712" actId="478"/>
          <ac:spMkLst>
            <pc:docMk/>
            <pc:sldMk cId="4048040299" sldId="259"/>
            <ac:spMk id="14" creationId="{B8FF2EC8-173F-4A2B-A293-F0FFA751DBFE}"/>
          </ac:spMkLst>
        </pc:spChg>
        <pc:spChg chg="mod">
          <ac:chgData name="Christine Vazquez" userId="baaf5e5e6abb5d23" providerId="LiveId" clId="{28E5ECB2-63AD-4C96-B683-90155CC8E582}" dt="2021-05-06T17:51:08.885" v="714" actId="1076"/>
          <ac:spMkLst>
            <pc:docMk/>
            <pc:sldMk cId="4048040299" sldId="259"/>
            <ac:spMk id="16" creationId="{661E0759-35B1-44A7-86BA-6B4EB5D5C1EB}"/>
          </ac:spMkLst>
        </pc:spChg>
        <pc:spChg chg="mod">
          <ac:chgData name="Christine Vazquez" userId="baaf5e5e6abb5d23" providerId="LiveId" clId="{28E5ECB2-63AD-4C96-B683-90155CC8E582}" dt="2021-05-06T17:51:08.885" v="714" actId="1076"/>
          <ac:spMkLst>
            <pc:docMk/>
            <pc:sldMk cId="4048040299" sldId="259"/>
            <ac:spMk id="18" creationId="{737E3DD5-EF71-43F2-9DEE-CAC7168995E4}"/>
          </ac:spMkLst>
        </pc:spChg>
        <pc:spChg chg="mod">
          <ac:chgData name="Christine Vazquez" userId="baaf5e5e6abb5d23" providerId="LiveId" clId="{28E5ECB2-63AD-4C96-B683-90155CC8E582}" dt="2021-05-06T17:51:08.885" v="714" actId="1076"/>
          <ac:spMkLst>
            <pc:docMk/>
            <pc:sldMk cId="4048040299" sldId="259"/>
            <ac:spMk id="21" creationId="{3B6742BC-65FB-4145-9DCA-8C4291884BD8}"/>
          </ac:spMkLst>
        </pc:spChg>
        <pc:spChg chg="mod">
          <ac:chgData name="Christine Vazquez" userId="baaf5e5e6abb5d23" providerId="LiveId" clId="{28E5ECB2-63AD-4C96-B683-90155CC8E582}" dt="2021-05-06T17:51:08.885" v="714" actId="1076"/>
          <ac:spMkLst>
            <pc:docMk/>
            <pc:sldMk cId="4048040299" sldId="259"/>
            <ac:spMk id="25" creationId="{3FAFF3F7-5773-4392-B19C-18DE66131ADD}"/>
          </ac:spMkLst>
        </pc:spChg>
        <pc:picChg chg="mod">
          <ac:chgData name="Christine Vazquez" userId="baaf5e5e6abb5d23" providerId="LiveId" clId="{28E5ECB2-63AD-4C96-B683-90155CC8E582}" dt="2021-05-06T17:51:08.885" v="714" actId="1076"/>
          <ac:picMkLst>
            <pc:docMk/>
            <pc:sldMk cId="4048040299" sldId="259"/>
            <ac:picMk id="4" creationId="{066C272C-5C91-4586-A01E-BA3A7221E2CE}"/>
          </ac:picMkLst>
        </pc:picChg>
        <pc:picChg chg="del">
          <ac:chgData name="Christine Vazquez" userId="baaf5e5e6abb5d23" providerId="LiveId" clId="{28E5ECB2-63AD-4C96-B683-90155CC8E582}" dt="2021-05-06T17:51:01.150" v="712" actId="478"/>
          <ac:picMkLst>
            <pc:docMk/>
            <pc:sldMk cId="4048040299" sldId="259"/>
            <ac:picMk id="5" creationId="{B7BC4480-6A30-40A8-8CE9-A537CBAF76B1}"/>
          </ac:picMkLst>
        </pc:picChg>
        <pc:picChg chg="del">
          <ac:chgData name="Christine Vazquez" userId="baaf5e5e6abb5d23" providerId="LiveId" clId="{28E5ECB2-63AD-4C96-B683-90155CC8E582}" dt="2021-05-06T17:51:01.150" v="712" actId="478"/>
          <ac:picMkLst>
            <pc:docMk/>
            <pc:sldMk cId="4048040299" sldId="259"/>
            <ac:picMk id="8" creationId="{B75E6E5E-7BC3-4A07-977A-D8C3232B725E}"/>
          </ac:picMkLst>
        </pc:picChg>
        <pc:picChg chg="mod">
          <ac:chgData name="Christine Vazquez" userId="baaf5e5e6abb5d23" providerId="LiveId" clId="{28E5ECB2-63AD-4C96-B683-90155CC8E582}" dt="2021-05-06T17:51:08.885" v="714" actId="1076"/>
          <ac:picMkLst>
            <pc:docMk/>
            <pc:sldMk cId="4048040299" sldId="259"/>
            <ac:picMk id="20" creationId="{819D35E8-84D6-4DC3-A359-840FF26D843A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7A6EA-BF5F-42C1-BB2F-BDFDAD3D29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02E9C6-F4E3-46C4-B0B8-D313FBB15D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EE2536-4EBE-4F5B-8C31-C31E44401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C00A07-103C-4778-B416-367DBD2930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C73B6B-BFA4-4BCD-AF30-7D060FDCC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112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77CA73-FFB1-4EA1-9C79-285F42EF88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73C7D3-A614-47D7-B55E-C39245B3EA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CC9F42-5C5E-4128-BB01-6ED92BF7C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0F789-5615-4C0E-B5DA-22F7B95CC8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6A90D3-E4B5-4481-8D25-2E5D6CA3E2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213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BCD434-98C9-43E9-A21A-7BD0BC9ED4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41DFAF-A44D-4DC0-868B-11E7C00CE4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194F4D-B3EF-4FEB-90E3-20916A7BF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2F08B2-A35B-4DCB-92EF-214DFB6197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686C05-A0C2-412E-9B68-A72A5D832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043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086866-F960-4D51-8C30-299EF19B7B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5BAAFB-1AC6-4A4B-B3D0-24C19B6FDD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A7B9BB-D6B9-4A24-A77D-5FDA7DF6E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1FDACF-D647-4D86-9F75-C1F32E9C7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841ACB-FE3F-4B67-A0D1-4631B630F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0349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1B4A6B-DE6B-4ACD-A9C4-C930DCDF4E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743EE2-8F66-4CE6-8B8A-CE3512B79C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0642C8-2FE9-4D75-9745-9A3F1AFEA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BF9CB3-B2FE-44AE-A628-D018AD8BFE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ED104C-2136-4DCD-8537-952134A22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974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157E25-11B8-448B-ACF5-804D64AAC3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A55AFB-48A6-49E6-AC10-57CB19A739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7E2AD9-23D8-4302-8C49-EE805DAB78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A1CB5A-122D-4F8B-AA51-8BFB04C23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2B27D6-D41C-4439-A56A-328C9264C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3032C6-0A7B-425B-98A0-355DD40CA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38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CA2CB1-8573-4A63-A0FB-1998C06C90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7E6726-17DF-40A9-A2A5-71BED08071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20BEB0-55A6-45A1-AFDF-C661C87035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BF0243C-753F-4C35-987E-61031B46B9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1F96ED-A4E8-4891-81DA-A0A5F7E288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00FD3D-0270-4E01-A345-857A47B93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AE9D00-B5EC-4371-9643-081988CA0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EF70F-8F7E-4597-921E-ED1448D82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731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AACA84-74A9-4A9E-8347-B996B4970F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0110AD-0C1F-41A0-A095-AD31A5F06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76BADD3-9E11-405D-9AF7-EE01E27385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3DFB86-0E4D-48E6-B740-6B0D749A8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460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0F2C97-6C70-4BAD-B08C-DC24BBA44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6BE06E3-E227-40E0-BD38-D46573F52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212C73-788C-4614-AA69-46949993B9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142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D9930F-2E06-45A6-8016-129727D58A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3D4202-3E88-485C-ADCF-704070BCB4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5DEA8C-F80E-4F31-97BD-BDE44FC570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554F16-0D8F-4A8F-AFA8-77DEA00B5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A127D2-8640-426E-806B-C078D168D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AA4C11-E1EE-49E6-8C3A-1CB0B3C89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227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D80DA7-D993-4BF5-B5CC-54C5E537C2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C0228D-1ABE-4825-B012-6368F70996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30A0C0-70C7-4945-BC77-CBDCD85A2C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1B7B89-CD49-4AAA-BA0C-7F02E5FF2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A7B44C-D36E-4C65-981B-9B23C0C50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89075E-214D-48BB-9BBA-6D811160F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940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94668F-4567-4149-97D0-48DC84A6E8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7D638D-653E-455D-A102-8E32A889BC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A0450F-69D8-484B-AC93-5B42A95F6F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A21C6-B55B-4BA5-B3D7-8DBDA383AA59}" type="datetimeFigureOut">
              <a:rPr lang="en-US" smtClean="0"/>
              <a:t>5/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EDA105-1562-4CAA-8FD3-7BCF461C2B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31B869-1568-4C04-ACE8-AF9CF30899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D827C-757D-4F88-987A-771CB00F1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728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jpg"/><Relationship Id="rId5" Type="http://schemas.openxmlformats.org/officeDocument/2006/relationships/image" Target="../media/image14.jpg"/><Relationship Id="rId4" Type="http://schemas.openxmlformats.org/officeDocument/2006/relationships/image" Target="../media/image13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g"/><Relationship Id="rId3" Type="http://schemas.openxmlformats.org/officeDocument/2006/relationships/image" Target="../media/image17.jpg"/><Relationship Id="rId7" Type="http://schemas.openxmlformats.org/officeDocument/2006/relationships/image" Target="../media/image21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jpg"/><Relationship Id="rId5" Type="http://schemas.openxmlformats.org/officeDocument/2006/relationships/image" Target="../media/image19.jpg"/><Relationship Id="rId10" Type="http://schemas.openxmlformats.org/officeDocument/2006/relationships/image" Target="../media/image24.png"/><Relationship Id="rId4" Type="http://schemas.openxmlformats.org/officeDocument/2006/relationships/image" Target="../media/image18.jpg"/><Relationship Id="rId9" Type="http://schemas.openxmlformats.org/officeDocument/2006/relationships/image" Target="../media/image2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8AEFDEE-EC82-C441-AA26-F7E5C1C78CD9}"/>
              </a:ext>
            </a:extLst>
          </p:cNvPr>
          <p:cNvSpPr txBox="1"/>
          <p:nvPr/>
        </p:nvSpPr>
        <p:spPr>
          <a:xfrm>
            <a:off x="253277" y="257949"/>
            <a:ext cx="2990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2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E194C45-2232-D34E-9DF0-7C3E84D79F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8702" y="1155343"/>
            <a:ext cx="2971800" cy="4089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F1FCD71-97B2-024A-B261-7CC3F01E3D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20443" y="1188357"/>
            <a:ext cx="2971800" cy="40894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CFE356A-41E3-CF4C-8829-CAD6170E146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96856" y="257949"/>
            <a:ext cx="2464870" cy="7656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5214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CB29B30-4CA7-4C3C-88AA-84A00B145E56}"/>
              </a:ext>
            </a:extLst>
          </p:cNvPr>
          <p:cNvSpPr txBox="1"/>
          <p:nvPr/>
        </p:nvSpPr>
        <p:spPr>
          <a:xfrm>
            <a:off x="67456" y="0"/>
            <a:ext cx="408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NFkB</a:t>
            </a:r>
            <a:r>
              <a:rPr lang="en-US" dirty="0"/>
              <a:t> and NSP13 – Figure 2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93F54B-EC1C-4517-9E90-90C0B3C1872B}"/>
              </a:ext>
            </a:extLst>
          </p:cNvPr>
          <p:cNvSpPr txBox="1"/>
          <p:nvPr/>
        </p:nvSpPr>
        <p:spPr>
          <a:xfrm>
            <a:off x="1409219" y="1463040"/>
            <a:ext cx="700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*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7B9C6F3-41B1-458B-AEDC-C3C9DC4B5D57}"/>
              </a:ext>
            </a:extLst>
          </p:cNvPr>
          <p:cNvSpPr txBox="1"/>
          <p:nvPr/>
        </p:nvSpPr>
        <p:spPr>
          <a:xfrm>
            <a:off x="0" y="3731349"/>
            <a:ext cx="2989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*This is residual Strep protein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46AEA08-858D-4A84-A2D0-668DD55173EC}"/>
              </a:ext>
            </a:extLst>
          </p:cNvPr>
          <p:cNvSpPr txBox="1"/>
          <p:nvPr/>
        </p:nvSpPr>
        <p:spPr>
          <a:xfrm>
            <a:off x="0" y="5657671"/>
            <a:ext cx="770455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n every gel, going from left to right, the order is:</a:t>
            </a:r>
          </a:p>
          <a:p>
            <a:pPr marL="342900" indent="-342900">
              <a:buAutoNum type="arabicPeriod"/>
            </a:pPr>
            <a:r>
              <a:rPr lang="en-US" dirty="0"/>
              <a:t>Vector only</a:t>
            </a:r>
          </a:p>
          <a:p>
            <a:pPr marL="342900" indent="-342900">
              <a:buAutoNum type="arabicPeriod"/>
            </a:pPr>
            <a:r>
              <a:rPr lang="en-US" dirty="0"/>
              <a:t>Flag-TBK1 only</a:t>
            </a:r>
          </a:p>
          <a:p>
            <a:pPr marL="342900" indent="-342900">
              <a:buAutoNum type="arabicPeriod"/>
            </a:pPr>
            <a:r>
              <a:rPr lang="en-US" dirty="0"/>
              <a:t>Flag-TBK1 + NSP13-Strep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AC2F7273-2F7B-4C53-995A-F2F78424FAD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72" t="12555" r="18215" b="28167"/>
          <a:stretch/>
        </p:blipFill>
        <p:spPr>
          <a:xfrm>
            <a:off x="8819535" y="814111"/>
            <a:ext cx="2982168" cy="3875876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5B2F8959-BE0B-4759-9FE7-E07A60CCA5F3}"/>
              </a:ext>
            </a:extLst>
          </p:cNvPr>
          <p:cNvSpPr txBox="1"/>
          <p:nvPr/>
        </p:nvSpPr>
        <p:spPr>
          <a:xfrm>
            <a:off x="10425728" y="4689987"/>
            <a:ext cx="1079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tin</a:t>
            </a:r>
          </a:p>
        </p:txBody>
      </p:sp>
      <p:pic>
        <p:nvPicPr>
          <p:cNvPr id="23" name="Picture 22" descr="A picture containing white&#10;&#10;Description automatically generated">
            <a:extLst>
              <a:ext uri="{FF2B5EF4-FFF2-40B4-BE49-F238E27FC236}">
                <a16:creationId xmlns:a16="http://schemas.microsoft.com/office/drawing/2014/main" id="{AE9DC049-2CA0-4E11-B6B4-14F139C188B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66" r="21974" b="26008"/>
          <a:stretch/>
        </p:blipFill>
        <p:spPr>
          <a:xfrm>
            <a:off x="97339" y="756034"/>
            <a:ext cx="2542622" cy="4432488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7C1BF507-4AF3-48D4-835B-BDBDF75E9FE2}"/>
              </a:ext>
            </a:extLst>
          </p:cNvPr>
          <p:cNvSpPr txBox="1"/>
          <p:nvPr/>
        </p:nvSpPr>
        <p:spPr>
          <a:xfrm>
            <a:off x="146899" y="4819190"/>
            <a:ext cx="1079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Fk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B2A5F7E-365A-484C-97C0-72D5259C6D92}"/>
              </a:ext>
            </a:extLst>
          </p:cNvPr>
          <p:cNvSpPr txBox="1"/>
          <p:nvPr/>
        </p:nvSpPr>
        <p:spPr>
          <a:xfrm>
            <a:off x="1718541" y="2274176"/>
            <a:ext cx="2542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 This is the correct band</a:t>
            </a:r>
          </a:p>
        </p:txBody>
      </p:sp>
      <p:pic>
        <p:nvPicPr>
          <p:cNvPr id="27" name="Picture 26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41FA0C26-D485-4332-9B12-74F40094488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34" t="13961" r="25780" b="21726"/>
          <a:stretch/>
        </p:blipFill>
        <p:spPr>
          <a:xfrm>
            <a:off x="4618355" y="322641"/>
            <a:ext cx="3273155" cy="4865881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9DD890E9-1997-4555-A981-91A760DA248C}"/>
              </a:ext>
            </a:extLst>
          </p:cNvPr>
          <p:cNvSpPr txBox="1"/>
          <p:nvPr/>
        </p:nvSpPr>
        <p:spPr>
          <a:xfrm>
            <a:off x="6838198" y="2202401"/>
            <a:ext cx="2542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 This is the correct band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DB4FF0F2-4C02-4A25-98DD-4D79DEC760FA}"/>
              </a:ext>
            </a:extLst>
          </p:cNvPr>
          <p:cNvSpPr/>
          <p:nvPr/>
        </p:nvSpPr>
        <p:spPr>
          <a:xfrm>
            <a:off x="5250426" y="2274176"/>
            <a:ext cx="1657719" cy="2975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5AFAD78-CA40-4DAF-B1C4-3991986C932C}"/>
              </a:ext>
            </a:extLst>
          </p:cNvPr>
          <p:cNvSpPr txBox="1"/>
          <p:nvPr/>
        </p:nvSpPr>
        <p:spPr>
          <a:xfrm>
            <a:off x="4638127" y="4856804"/>
            <a:ext cx="18526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hospho-NFk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6E60C70-8A19-4E0D-AE32-814821C440C4}"/>
              </a:ext>
            </a:extLst>
          </p:cNvPr>
          <p:cNvSpPr txBox="1"/>
          <p:nvPr/>
        </p:nvSpPr>
        <p:spPr>
          <a:xfrm>
            <a:off x="5197332" y="5226136"/>
            <a:ext cx="413039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ink is oversaturation of non-specific bands that was automatically done by our </a:t>
            </a:r>
            <a:r>
              <a:rPr lang="en-US" dirty="0" err="1"/>
              <a:t>Amersham</a:t>
            </a:r>
            <a:r>
              <a:rPr lang="en-US" dirty="0"/>
              <a:t> imager while trying to expose the </a:t>
            </a:r>
            <a:r>
              <a:rPr lang="en-US" dirty="0" err="1"/>
              <a:t>pNFkB</a:t>
            </a:r>
            <a:r>
              <a:rPr lang="en-US" dirty="0"/>
              <a:t> signal on this blot. </a:t>
            </a:r>
          </a:p>
        </p:txBody>
      </p:sp>
    </p:spTree>
    <p:extLst>
      <p:ext uri="{BB962C8B-B14F-4D97-AF65-F5344CB8AC3E}">
        <p14:creationId xmlns:p14="http://schemas.microsoft.com/office/powerpoint/2010/main" val="39759219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CB29B30-4CA7-4C3C-88AA-84A00B145E56}"/>
              </a:ext>
            </a:extLst>
          </p:cNvPr>
          <p:cNvSpPr txBox="1"/>
          <p:nvPr/>
        </p:nvSpPr>
        <p:spPr>
          <a:xfrm>
            <a:off x="67456" y="0"/>
            <a:ext cx="408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NFkB</a:t>
            </a:r>
            <a:r>
              <a:rPr lang="en-US" dirty="0"/>
              <a:t> and NSP13 – Figure 2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46AEA08-858D-4A84-A2D0-668DD55173EC}"/>
              </a:ext>
            </a:extLst>
          </p:cNvPr>
          <p:cNvSpPr txBox="1"/>
          <p:nvPr/>
        </p:nvSpPr>
        <p:spPr>
          <a:xfrm>
            <a:off x="0" y="5657671"/>
            <a:ext cx="770455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n every gel, going from left to right, the order is:</a:t>
            </a:r>
          </a:p>
          <a:p>
            <a:pPr marL="342900" indent="-342900">
              <a:buAutoNum type="arabicPeriod"/>
            </a:pPr>
            <a:r>
              <a:rPr lang="en-US" dirty="0"/>
              <a:t>Vector only</a:t>
            </a:r>
          </a:p>
          <a:p>
            <a:pPr marL="342900" indent="-342900">
              <a:buAutoNum type="arabicPeriod"/>
            </a:pPr>
            <a:r>
              <a:rPr lang="en-US" dirty="0"/>
              <a:t>Flag-TBK1 only</a:t>
            </a:r>
          </a:p>
          <a:p>
            <a:pPr marL="342900" indent="-342900">
              <a:buAutoNum type="arabicPeriod"/>
            </a:pPr>
            <a:r>
              <a:rPr lang="en-US" dirty="0"/>
              <a:t>Flag-TBK1 + NSP13-Strep</a:t>
            </a:r>
          </a:p>
        </p:txBody>
      </p:sp>
      <p:pic>
        <p:nvPicPr>
          <p:cNvPr id="8" name="Picture 7" descr="A picture containing white&#10;&#10;Description automatically generated">
            <a:extLst>
              <a:ext uri="{FF2B5EF4-FFF2-40B4-BE49-F238E27FC236}">
                <a16:creationId xmlns:a16="http://schemas.microsoft.com/office/drawing/2014/main" id="{A60DD0C6-6431-4A59-AF16-8350FED8335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42" r="22038" b="30999"/>
          <a:stretch/>
        </p:blipFill>
        <p:spPr>
          <a:xfrm>
            <a:off x="142407" y="566075"/>
            <a:ext cx="3770026" cy="5174857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3BAF2E31-A226-4F22-9372-665337AE2514}"/>
              </a:ext>
            </a:extLst>
          </p:cNvPr>
          <p:cNvSpPr txBox="1"/>
          <p:nvPr/>
        </p:nvSpPr>
        <p:spPr>
          <a:xfrm>
            <a:off x="142407" y="5276262"/>
            <a:ext cx="1079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trep</a:t>
            </a:r>
          </a:p>
        </p:txBody>
      </p:sp>
      <p:pic>
        <p:nvPicPr>
          <p:cNvPr id="10" name="Picture 9" descr="A picture containing indoor, white&#10;&#10;Description automatically generated">
            <a:extLst>
              <a:ext uri="{FF2B5EF4-FFF2-40B4-BE49-F238E27FC236}">
                <a16:creationId xmlns:a16="http://schemas.microsoft.com/office/drawing/2014/main" id="{E4712A84-9719-420E-A5BD-FC03ED9F14F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12" r="17409" b="21575"/>
          <a:stretch/>
        </p:blipFill>
        <p:spPr>
          <a:xfrm>
            <a:off x="6205928" y="561182"/>
            <a:ext cx="3770026" cy="5735636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595DF994-1F5F-4755-BC56-E9B60D3D3A68}"/>
              </a:ext>
            </a:extLst>
          </p:cNvPr>
          <p:cNvSpPr txBox="1"/>
          <p:nvPr/>
        </p:nvSpPr>
        <p:spPr>
          <a:xfrm>
            <a:off x="6283377" y="5885516"/>
            <a:ext cx="1079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BK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1B962E1-2098-42A5-A712-F09DFAD2A9B5}"/>
              </a:ext>
            </a:extLst>
          </p:cNvPr>
          <p:cNvSpPr txBox="1"/>
          <p:nvPr/>
        </p:nvSpPr>
        <p:spPr>
          <a:xfrm>
            <a:off x="8517096" y="2914434"/>
            <a:ext cx="2542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 This is the correct band</a:t>
            </a:r>
          </a:p>
        </p:txBody>
      </p:sp>
    </p:spTree>
    <p:extLst>
      <p:ext uri="{BB962C8B-B14F-4D97-AF65-F5344CB8AC3E}">
        <p14:creationId xmlns:p14="http://schemas.microsoft.com/office/powerpoint/2010/main" val="2949240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5756FC0-23CB-AB4A-AA86-38FBEE1DAFEC}"/>
              </a:ext>
            </a:extLst>
          </p:cNvPr>
          <p:cNvSpPr txBox="1"/>
          <p:nvPr/>
        </p:nvSpPr>
        <p:spPr>
          <a:xfrm>
            <a:off x="253277" y="257949"/>
            <a:ext cx="2990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3C</a:t>
            </a:r>
          </a:p>
        </p:txBody>
      </p:sp>
      <p:pic>
        <p:nvPicPr>
          <p:cNvPr id="3" name="Picture 2" descr="A close up of a logo&#10;&#10;Description automatically generated">
            <a:extLst>
              <a:ext uri="{FF2B5EF4-FFF2-40B4-BE49-F238E27FC236}">
                <a16:creationId xmlns:a16="http://schemas.microsoft.com/office/drawing/2014/main" id="{D85A6363-A1D6-47D7-8756-CE5639E7BC8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0152"/>
          <a:stretch/>
        </p:blipFill>
        <p:spPr>
          <a:xfrm rot="5400000">
            <a:off x="5079081" y="2110540"/>
            <a:ext cx="5059619" cy="346794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0515A80-A48C-4A36-AC89-D7A5C5ADB8BB}"/>
              </a:ext>
            </a:extLst>
          </p:cNvPr>
          <p:cNvSpPr txBox="1"/>
          <p:nvPr/>
        </p:nvSpPr>
        <p:spPr>
          <a:xfrm>
            <a:off x="6923531" y="5727992"/>
            <a:ext cx="11785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</a:t>
            </a:r>
            <a:r>
              <a:rPr lang="el-GR" dirty="0"/>
              <a:t>α</a:t>
            </a:r>
            <a:r>
              <a:rPr lang="en-US" dirty="0"/>
              <a:t>Actin </a:t>
            </a:r>
          </a:p>
          <a:p>
            <a:r>
              <a:rPr lang="en-US" dirty="0"/>
              <a:t>1:1000</a:t>
            </a:r>
            <a:endParaRPr lang="en-GB" dirty="0"/>
          </a:p>
        </p:txBody>
      </p:sp>
      <p:pic>
        <p:nvPicPr>
          <p:cNvPr id="9" name="Picture 8" descr="A picture containing indoor, mirror, sitting, photo&#10;&#10;Description automatically generated">
            <a:extLst>
              <a:ext uri="{FF2B5EF4-FFF2-40B4-BE49-F238E27FC236}">
                <a16:creationId xmlns:a16="http://schemas.microsoft.com/office/drawing/2014/main" id="{C1DCB773-859E-445F-BE22-23A2DB4411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650" y="1599969"/>
            <a:ext cx="5290604" cy="384771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A0E3CB1-7669-4D4E-B5A7-50FBFF9FF3A4}"/>
              </a:ext>
            </a:extLst>
          </p:cNvPr>
          <p:cNvSpPr txBox="1"/>
          <p:nvPr/>
        </p:nvSpPr>
        <p:spPr>
          <a:xfrm>
            <a:off x="1876525" y="4934865"/>
            <a:ext cx="19168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treptavidin-HRP</a:t>
            </a:r>
          </a:p>
          <a:p>
            <a:pPr algn="ctr"/>
            <a:r>
              <a:rPr lang="en-US" dirty="0"/>
              <a:t>1:10,000</a:t>
            </a:r>
            <a:endParaRPr lang="en-GB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0090F41-AB14-4B55-A804-E6DCC952730D}"/>
              </a:ext>
            </a:extLst>
          </p:cNvPr>
          <p:cNvSpPr txBox="1"/>
          <p:nvPr/>
        </p:nvSpPr>
        <p:spPr>
          <a:xfrm>
            <a:off x="5979530" y="1695583"/>
            <a:ext cx="922666" cy="369332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dirty="0"/>
              <a:t>NSP1</a:t>
            </a:r>
            <a:endParaRPr lang="en-GB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51C2609-28C2-4C09-9C5F-A87052AD795F}"/>
              </a:ext>
            </a:extLst>
          </p:cNvPr>
          <p:cNvSpPr txBox="1"/>
          <p:nvPr/>
        </p:nvSpPr>
        <p:spPr>
          <a:xfrm>
            <a:off x="6521481" y="1695583"/>
            <a:ext cx="922666" cy="369332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dirty="0"/>
              <a:t>NSP9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CF99A8D-B5BE-4678-A721-6C5A2627CC0D}"/>
              </a:ext>
            </a:extLst>
          </p:cNvPr>
          <p:cNvSpPr txBox="1"/>
          <p:nvPr/>
        </p:nvSpPr>
        <p:spPr>
          <a:xfrm>
            <a:off x="7097764" y="1695583"/>
            <a:ext cx="922666" cy="369332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dirty="0"/>
              <a:t>KHA</a:t>
            </a:r>
            <a:endParaRPr lang="en-GB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C336F1E-8F9B-4D33-A899-55781A848D65}"/>
              </a:ext>
            </a:extLst>
          </p:cNvPr>
          <p:cNvSpPr txBox="1"/>
          <p:nvPr/>
        </p:nvSpPr>
        <p:spPr>
          <a:xfrm>
            <a:off x="7605384" y="1695583"/>
            <a:ext cx="830093" cy="369332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dirty="0"/>
              <a:t>RKA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4EE7879-F753-4763-A3F8-C527D8EC14B0}"/>
              </a:ext>
            </a:extLst>
          </p:cNvPr>
          <p:cNvSpPr txBox="1"/>
          <p:nvPr/>
        </p:nvSpPr>
        <p:spPr>
          <a:xfrm rot="16200000">
            <a:off x="1945925" y="1623328"/>
            <a:ext cx="922666" cy="369332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dirty="0"/>
              <a:t>NSP1</a:t>
            </a:r>
            <a:endParaRPr lang="en-GB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862E34D-6316-452A-8DCF-34FEB1217BB1}"/>
              </a:ext>
            </a:extLst>
          </p:cNvPr>
          <p:cNvSpPr txBox="1"/>
          <p:nvPr/>
        </p:nvSpPr>
        <p:spPr>
          <a:xfrm rot="16200000">
            <a:off x="2314345" y="1623328"/>
            <a:ext cx="922666" cy="369332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dirty="0"/>
              <a:t>NSP9</a:t>
            </a:r>
            <a:endParaRPr lang="en-GB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B7800AD-3B1F-45B2-9C2B-A2B19DC38FEF}"/>
              </a:ext>
            </a:extLst>
          </p:cNvPr>
          <p:cNvSpPr txBox="1"/>
          <p:nvPr/>
        </p:nvSpPr>
        <p:spPr>
          <a:xfrm rot="16200000">
            <a:off x="2674388" y="1623328"/>
            <a:ext cx="922666" cy="369332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dirty="0"/>
              <a:t>KHA</a:t>
            </a:r>
            <a:endParaRPr lang="en-GB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AA50FE6-E6CF-47A2-9B2A-D593DF8A3E2F}"/>
              </a:ext>
            </a:extLst>
          </p:cNvPr>
          <p:cNvSpPr txBox="1"/>
          <p:nvPr/>
        </p:nvSpPr>
        <p:spPr>
          <a:xfrm rot="16200000">
            <a:off x="3129611" y="1669614"/>
            <a:ext cx="830093" cy="369332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n-US" dirty="0"/>
              <a:t>RKA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10828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CB29B30-4CA7-4C3C-88AA-84A00B145E56}"/>
              </a:ext>
            </a:extLst>
          </p:cNvPr>
          <p:cNvSpPr txBox="1"/>
          <p:nvPr/>
        </p:nvSpPr>
        <p:spPr>
          <a:xfrm>
            <a:off x="67456" y="0"/>
            <a:ext cx="4084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SP13 and TBK1 IP – Figure 4a</a:t>
            </a:r>
          </a:p>
        </p:txBody>
      </p:sp>
      <p:pic>
        <p:nvPicPr>
          <p:cNvPr id="6" name="Picture 5" descr="A picture containing linedrawing&#10;&#10;Description automatically generated">
            <a:extLst>
              <a:ext uri="{FF2B5EF4-FFF2-40B4-BE49-F238E27FC236}">
                <a16:creationId xmlns:a16="http://schemas.microsoft.com/office/drawing/2014/main" id="{7198F30A-FB55-4ACF-B01F-C8BED3AB7C2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28" t="20479" r="23693" b="23951"/>
          <a:stretch/>
        </p:blipFill>
        <p:spPr>
          <a:xfrm>
            <a:off x="7801504" y="369332"/>
            <a:ext cx="2858345" cy="3546683"/>
          </a:xfrm>
          <a:prstGeom prst="rect">
            <a:avLst/>
          </a:prstGeom>
        </p:spPr>
      </p:pic>
      <p:pic>
        <p:nvPicPr>
          <p:cNvPr id="8" name="Picture 7" descr="A picture containing text&#10;&#10;Description automatically generated">
            <a:extLst>
              <a:ext uri="{FF2B5EF4-FFF2-40B4-BE49-F238E27FC236}">
                <a16:creationId xmlns:a16="http://schemas.microsoft.com/office/drawing/2014/main" id="{B3C2DF4D-C1A7-4D91-8BA1-19CDCB4AC85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2332" y="667062"/>
            <a:ext cx="2981992" cy="4100239"/>
          </a:xfrm>
          <a:prstGeom prst="rect">
            <a:avLst/>
          </a:prstGeom>
        </p:spPr>
      </p:pic>
      <p:pic>
        <p:nvPicPr>
          <p:cNvPr id="10" name="Picture 9" descr="A picture containing wall, indoor, white, jack&#10;&#10;Description automatically generated">
            <a:extLst>
              <a:ext uri="{FF2B5EF4-FFF2-40B4-BE49-F238E27FC236}">
                <a16:creationId xmlns:a16="http://schemas.microsoft.com/office/drawing/2014/main" id="{30026CCB-5548-4DD0-805E-8C6BC991D70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68" t="19382" r="16218" b="25414"/>
          <a:stretch/>
        </p:blipFill>
        <p:spPr>
          <a:xfrm>
            <a:off x="7801504" y="3672688"/>
            <a:ext cx="2858345" cy="3185312"/>
          </a:xfrm>
          <a:prstGeom prst="rect">
            <a:avLst/>
          </a:prstGeom>
        </p:spPr>
      </p:pic>
      <p:pic>
        <p:nvPicPr>
          <p:cNvPr id="12" name="Picture 11" descr="A picture containing text&#10;&#10;Description automatically generated">
            <a:extLst>
              <a:ext uri="{FF2B5EF4-FFF2-40B4-BE49-F238E27FC236}">
                <a16:creationId xmlns:a16="http://schemas.microsoft.com/office/drawing/2014/main" id="{2AC0EE73-081D-4C81-9DA2-7BDCC5FF91B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37" t="28922" r="21329" b="15326"/>
          <a:stretch/>
        </p:blipFill>
        <p:spPr>
          <a:xfrm>
            <a:off x="66733" y="667062"/>
            <a:ext cx="2855626" cy="3506252"/>
          </a:xfrm>
          <a:prstGeom prst="rect">
            <a:avLst/>
          </a:prstGeom>
        </p:spPr>
      </p:pic>
      <p:pic>
        <p:nvPicPr>
          <p:cNvPr id="14" name="Picture 13" descr="A roll of toilet paper&#10;&#10;Description automatically generated">
            <a:extLst>
              <a:ext uri="{FF2B5EF4-FFF2-40B4-BE49-F238E27FC236}">
                <a16:creationId xmlns:a16="http://schemas.microsoft.com/office/drawing/2014/main" id="{E0CF60F0-7846-4A48-AE5A-5C64D175CD0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63" t="20478" r="26458" b="21758"/>
          <a:stretch/>
        </p:blipFill>
        <p:spPr>
          <a:xfrm>
            <a:off x="385273" y="4401237"/>
            <a:ext cx="1836295" cy="236844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44A76DC-96DB-4930-BBED-602D62421115}"/>
              </a:ext>
            </a:extLst>
          </p:cNvPr>
          <p:cNvSpPr txBox="1"/>
          <p:nvPr/>
        </p:nvSpPr>
        <p:spPr>
          <a:xfrm>
            <a:off x="6030473" y="-60780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7AFA2F1-A658-475A-AE5A-8D2E63A12169}"/>
              </a:ext>
            </a:extLst>
          </p:cNvPr>
          <p:cNvSpPr txBox="1"/>
          <p:nvPr/>
        </p:nvSpPr>
        <p:spPr>
          <a:xfrm>
            <a:off x="5263602" y="-60780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C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65513D6-19BC-472C-A44F-F68DD8C068F0}"/>
              </a:ext>
            </a:extLst>
          </p:cNvPr>
          <p:cNvSpPr txBox="1"/>
          <p:nvPr/>
        </p:nvSpPr>
        <p:spPr>
          <a:xfrm>
            <a:off x="5175303" y="2469502"/>
            <a:ext cx="1079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la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216DBDF-D934-4EA1-A0E8-47A8FA3B1C47}"/>
              </a:ext>
            </a:extLst>
          </p:cNvPr>
          <p:cNvSpPr txBox="1"/>
          <p:nvPr/>
        </p:nvSpPr>
        <p:spPr>
          <a:xfrm>
            <a:off x="10925605" y="4975745"/>
            <a:ext cx="1079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tre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CCE87A1-D8AA-4791-A055-9EA73B1600FA}"/>
              </a:ext>
            </a:extLst>
          </p:cNvPr>
          <p:cNvSpPr txBox="1"/>
          <p:nvPr/>
        </p:nvSpPr>
        <p:spPr>
          <a:xfrm>
            <a:off x="10912823" y="2155853"/>
            <a:ext cx="1079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la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4A845CB-AC71-4D3E-A562-826E702F43D3}"/>
              </a:ext>
            </a:extLst>
          </p:cNvPr>
          <p:cNvSpPr txBox="1"/>
          <p:nvPr/>
        </p:nvSpPr>
        <p:spPr>
          <a:xfrm>
            <a:off x="1510672" y="6325714"/>
            <a:ext cx="1079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tre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07BDC33-BB40-49EB-9E55-195D1E0463CE}"/>
              </a:ext>
            </a:extLst>
          </p:cNvPr>
          <p:cNvSpPr txBox="1"/>
          <p:nvPr/>
        </p:nvSpPr>
        <p:spPr>
          <a:xfrm>
            <a:off x="2109865" y="3069667"/>
            <a:ext cx="10795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ubul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93F54B-EC1C-4517-9E90-90C0B3C1872B}"/>
              </a:ext>
            </a:extLst>
          </p:cNvPr>
          <p:cNvSpPr txBox="1"/>
          <p:nvPr/>
        </p:nvSpPr>
        <p:spPr>
          <a:xfrm>
            <a:off x="1409219" y="1463040"/>
            <a:ext cx="700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7B9C6F3-41B1-458B-AEDC-C3C9DC4B5D57}"/>
              </a:ext>
            </a:extLst>
          </p:cNvPr>
          <p:cNvSpPr txBox="1"/>
          <p:nvPr/>
        </p:nvSpPr>
        <p:spPr>
          <a:xfrm>
            <a:off x="0" y="3731349"/>
            <a:ext cx="2989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*</a:t>
            </a:r>
            <a:r>
              <a:rPr lang="en-US" dirty="0"/>
              <a:t>This is residual Strep protein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46AEA08-858D-4A84-A2D0-668DD55173EC}"/>
              </a:ext>
            </a:extLst>
          </p:cNvPr>
          <p:cNvSpPr txBox="1"/>
          <p:nvPr/>
        </p:nvSpPr>
        <p:spPr>
          <a:xfrm>
            <a:off x="2922359" y="5305054"/>
            <a:ext cx="310811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n every gel, going from left to right, the order is:</a:t>
            </a:r>
          </a:p>
          <a:p>
            <a:pPr marL="342900" indent="-342900">
              <a:buAutoNum type="arabicPeriod"/>
            </a:pPr>
            <a:r>
              <a:rPr lang="en-US" dirty="0"/>
              <a:t>Vector only</a:t>
            </a:r>
          </a:p>
          <a:p>
            <a:pPr marL="342900" indent="-342900">
              <a:buAutoNum type="arabicPeriod"/>
            </a:pPr>
            <a:r>
              <a:rPr lang="en-US" dirty="0"/>
              <a:t>Flag-TBK1 only</a:t>
            </a:r>
          </a:p>
          <a:p>
            <a:pPr marL="342900" indent="-342900">
              <a:buAutoNum type="arabicPeriod"/>
            </a:pPr>
            <a:r>
              <a:rPr lang="en-US" dirty="0"/>
              <a:t>Flag-TBK1 + NSP13-Strep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AC220F2-9534-481F-AF81-F169121F44B0}"/>
              </a:ext>
            </a:extLst>
          </p:cNvPr>
          <p:cNvCxnSpPr/>
          <p:nvPr/>
        </p:nvCxnSpPr>
        <p:spPr>
          <a:xfrm>
            <a:off x="6096000" y="0"/>
            <a:ext cx="0" cy="6782382"/>
          </a:xfrm>
          <a:prstGeom prst="line">
            <a:avLst/>
          </a:prstGeom>
          <a:ln w="28575"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3826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9DEE156-3678-5647-897D-4A008C5804D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168"/>
          <a:stretch/>
        </p:blipFill>
        <p:spPr>
          <a:xfrm>
            <a:off x="7389839" y="1743311"/>
            <a:ext cx="1332879" cy="3169053"/>
          </a:xfrm>
          <a:prstGeom prst="rect">
            <a:avLst/>
          </a:prstGeom>
        </p:spPr>
      </p:pic>
      <p:pic>
        <p:nvPicPr>
          <p:cNvPr id="5" name="Content Placeholder 3">
            <a:extLst>
              <a:ext uri="{FF2B5EF4-FFF2-40B4-BE49-F238E27FC236}">
                <a16:creationId xmlns:a16="http://schemas.microsoft.com/office/drawing/2014/main" id="{CA659176-277B-2848-A09C-9F96245406F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2384"/>
          <a:stretch/>
        </p:blipFill>
        <p:spPr>
          <a:xfrm>
            <a:off x="773771" y="1731773"/>
            <a:ext cx="974931" cy="281527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33221F5-004C-F642-AFC9-D41E20A3C9AB}"/>
              </a:ext>
            </a:extLst>
          </p:cNvPr>
          <p:cNvSpPr txBox="1"/>
          <p:nvPr/>
        </p:nvSpPr>
        <p:spPr>
          <a:xfrm>
            <a:off x="849088" y="1682980"/>
            <a:ext cx="29908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P-TBK1 </a:t>
            </a:r>
          </a:p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1:100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34663B-D01B-294F-A63B-2721D0079D5A}"/>
              </a:ext>
            </a:extLst>
          </p:cNvPr>
          <p:cNvSpPr txBox="1"/>
          <p:nvPr/>
        </p:nvSpPr>
        <p:spPr>
          <a:xfrm rot="295351">
            <a:off x="849973" y="3416409"/>
            <a:ext cx="27574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  2  3  4  5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21F3AFE5-C0A8-1042-9834-C87C949E204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492"/>
          <a:stretch/>
        </p:blipFill>
        <p:spPr>
          <a:xfrm>
            <a:off x="2184522" y="1760802"/>
            <a:ext cx="974931" cy="255302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055327A-2A25-D247-B4A1-D45A3221E0C4}"/>
              </a:ext>
            </a:extLst>
          </p:cNvPr>
          <p:cNvSpPr txBox="1"/>
          <p:nvPr/>
        </p:nvSpPr>
        <p:spPr>
          <a:xfrm>
            <a:off x="2242494" y="1731773"/>
            <a:ext cx="15906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Flag AB: </a:t>
            </a:r>
          </a:p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RB 1:1000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42433F54-6BDB-A04D-9619-DA5E17ADC89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168"/>
          <a:stretch/>
        </p:blipFill>
        <p:spPr>
          <a:xfrm>
            <a:off x="3368396" y="1743311"/>
            <a:ext cx="1107312" cy="263274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1FF5109-E83A-C841-AC16-08C384214E4D}"/>
              </a:ext>
            </a:extLst>
          </p:cNvPr>
          <p:cNvSpPr txBox="1"/>
          <p:nvPr/>
        </p:nvSpPr>
        <p:spPr>
          <a:xfrm>
            <a:off x="3507912" y="1682980"/>
            <a:ext cx="15906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iFIT1: </a:t>
            </a:r>
          </a:p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RB 1:1000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03DB1479-F07D-4445-9837-0E03111C089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43286"/>
          <a:stretch/>
        </p:blipFill>
        <p:spPr>
          <a:xfrm>
            <a:off x="5939766" y="1731773"/>
            <a:ext cx="1241214" cy="300928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05FC99F-FA48-284F-9647-A99588B93C71}"/>
              </a:ext>
            </a:extLst>
          </p:cNvPr>
          <p:cNvSpPr txBox="1"/>
          <p:nvPr/>
        </p:nvSpPr>
        <p:spPr>
          <a:xfrm>
            <a:off x="5985040" y="1810214"/>
            <a:ext cx="17861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Tubulin: </a:t>
            </a:r>
          </a:p>
          <a:p>
            <a:r>
              <a:rPr lang="en-US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ms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 1:100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AFB41AC-7598-8046-8DC4-24F9F5F711F5}"/>
              </a:ext>
            </a:extLst>
          </p:cNvPr>
          <p:cNvSpPr txBox="1"/>
          <p:nvPr/>
        </p:nvSpPr>
        <p:spPr>
          <a:xfrm>
            <a:off x="7683481" y="1804867"/>
            <a:ext cx="17861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IRF3: </a:t>
            </a:r>
          </a:p>
          <a:p>
            <a:r>
              <a:rPr lang="en-US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ms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 1:1000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8B0AFB0E-8D1E-614B-AA10-C0AB48B5DA43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1445"/>
          <a:stretch/>
        </p:blipFill>
        <p:spPr>
          <a:xfrm>
            <a:off x="9028751" y="1745444"/>
            <a:ext cx="852801" cy="304140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32F2F435-7E0C-A247-8703-1DE695DD8C81}"/>
              </a:ext>
            </a:extLst>
          </p:cNvPr>
          <p:cNvSpPr txBox="1"/>
          <p:nvPr/>
        </p:nvSpPr>
        <p:spPr>
          <a:xfrm>
            <a:off x="8984900" y="1776116"/>
            <a:ext cx="15573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Strep: </a:t>
            </a:r>
          </a:p>
          <a:p>
            <a:r>
              <a:rPr lang="en-US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ms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 1:1000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BC2D2C3E-44F1-774C-85C9-E069203E2C12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6280"/>
          <a:stretch/>
        </p:blipFill>
        <p:spPr>
          <a:xfrm>
            <a:off x="4706393" y="1731773"/>
            <a:ext cx="1007651" cy="316905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979A63A-478A-0748-B266-5A500070A3C8}"/>
              </a:ext>
            </a:extLst>
          </p:cNvPr>
          <p:cNvSpPr txBox="1"/>
          <p:nvPr/>
        </p:nvSpPr>
        <p:spPr>
          <a:xfrm>
            <a:off x="4788507" y="1803283"/>
            <a:ext cx="29908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P-IRF3 </a:t>
            </a:r>
          </a:p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1:1000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26B27BD1-AD6E-344B-A3E4-CF9262BB4B9A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157"/>
          <a:stretch/>
        </p:blipFill>
        <p:spPr>
          <a:xfrm>
            <a:off x="10239316" y="1714084"/>
            <a:ext cx="1217910" cy="316905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7D160B23-6BC0-3847-9354-AF84D4CB5454}"/>
              </a:ext>
            </a:extLst>
          </p:cNvPr>
          <p:cNvSpPr txBox="1"/>
          <p:nvPr/>
        </p:nvSpPr>
        <p:spPr>
          <a:xfrm>
            <a:off x="10398513" y="1810214"/>
            <a:ext cx="15573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TBK1: </a:t>
            </a:r>
          </a:p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RB 1:10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AC3CB19-9884-954E-8312-4A118D7E8B62}"/>
              </a:ext>
            </a:extLst>
          </p:cNvPr>
          <p:cNvSpPr txBox="1"/>
          <p:nvPr/>
        </p:nvSpPr>
        <p:spPr>
          <a:xfrm>
            <a:off x="253277" y="257949"/>
            <a:ext cx="2990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4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FC56E76-A81C-734D-ABA4-E9E01AB6410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99404" y="1355169"/>
            <a:ext cx="1149298" cy="271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9171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205</Words>
  <Application>Microsoft Macintosh PowerPoint</Application>
  <PresentationFormat>Widescreen</PresentationFormat>
  <Paragraphs>6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 Vazquez</dc:creator>
  <cp:lastModifiedBy>Kellie Jurado</cp:lastModifiedBy>
  <cp:revision>2</cp:revision>
  <dcterms:created xsi:type="dcterms:W3CDTF">2021-05-06T15:17:05Z</dcterms:created>
  <dcterms:modified xsi:type="dcterms:W3CDTF">2021-05-08T12:36:29Z</dcterms:modified>
</cp:coreProperties>
</file>